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4.tif" ContentType="image/png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E755FE50-582A-BF4C-A018-AE5AAE357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445" y="1433015"/>
            <a:ext cx="2447834" cy="2447834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0AAD1C9B-B86E-AD46-9F39-3C7DF10F8E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249" y="1433015"/>
            <a:ext cx="2456377" cy="2456377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8EF1DC61-D2A0-DA47-975A-B05D9D0048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445" y="4007078"/>
            <a:ext cx="2447834" cy="2447834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1CCB6D72-8CFF-684D-98E6-57248A64EF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1249" y="3985566"/>
            <a:ext cx="2469346" cy="2469346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J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z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Sox2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 (ag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-2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Sox-2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olyclonal rabbit anti-Sox2 (Abcam, Cat. No ab97959, dilution 1:50)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05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6</cp:revision>
  <dcterms:created xsi:type="dcterms:W3CDTF">2020-05-09T12:35:08Z</dcterms:created>
  <dcterms:modified xsi:type="dcterms:W3CDTF">2020-05-27T16:56:39Z</dcterms:modified>
</cp:coreProperties>
</file>